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9567" autoAdjust="0"/>
    <p:restoredTop sz="94660"/>
  </p:normalViewPr>
  <p:slideViewPr>
    <p:cSldViewPr snapToGrid="0">
      <p:cViewPr>
        <p:scale>
          <a:sx n="120" d="100"/>
          <a:sy n="120" d="100"/>
        </p:scale>
        <p:origin x="-320" y="-2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678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373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7280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4165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8962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99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829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506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533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492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833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72E5BF-3F37-497A-B38D-AAA5B594D8B1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C0F60-A17A-4999-AA49-D07B11CAFB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155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C6DE40-4AFB-EA45-9E12-A5FB66AE7F12}"/>
              </a:ext>
            </a:extLst>
          </p:cNvPr>
          <p:cNvSpPr txBox="1"/>
          <p:nvPr/>
        </p:nvSpPr>
        <p:spPr>
          <a:xfrm>
            <a:off x="583050" y="7822554"/>
            <a:ext cx="56919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/>
              <a:t>Supplementary Figure S1. Phylogenetic trees of </a:t>
            </a:r>
            <a:r>
              <a:rPr lang="en-US" sz="800" b="1" i="1" dirty="0"/>
              <a:t>C. elegans </a:t>
            </a:r>
            <a:r>
              <a:rPr lang="en-US" sz="800" b="1" dirty="0"/>
              <a:t>HRPs and PTRs and number of conserved paralogs of the HHLS pathway in selected nematodes species of four different clades. </a:t>
            </a:r>
            <a:r>
              <a:rPr lang="en-US" sz="800" dirty="0"/>
              <a:t>Phylogenetic trees were constructed using the neighbor-joining method based on a multiple alignment (ClustalW) of amino acid sequences. Bootstrap values supporting tree nodes are indicated as percentage of 1000 repetitions assuming the Jukes Cantor amino acid evolution model. (A) groundhog-like (GRL/GRD) and related genes including human sonic hedgehog. (B) warthog-like (WRT) and related genes including human sonic hedgehog (SHH). (C) patched-like (PTR/PTC/PTD) and related genes including human patched (PTC1) and dispatched (DISP1). (D) Expansion of the HHLS pathway in nematodes. </a:t>
            </a:r>
            <a:r>
              <a:rPr lang="en-US" sz="800" baseline="30000" dirty="0"/>
              <a:t>1</a:t>
            </a:r>
            <a:r>
              <a:rPr lang="en-US" sz="800" dirty="0"/>
              <a:t>Paralogues identified in Wormbase Parasite by performing a cDNA TBLASTN search for distant homologues to </a:t>
            </a:r>
            <a:r>
              <a:rPr lang="en-US" sz="800" i="1" dirty="0"/>
              <a:t>C. elegans</a:t>
            </a:r>
            <a:r>
              <a:rPr lang="en-US" sz="800" dirty="0"/>
              <a:t> WRT-1, WRT-8, GRD-1, GRL-1, GRL-7 (ligands) and PTR-1, PTR-18, PTC-1, CHE-14 (receptors) followed by species per species paralogue search (numbers of paralogues may be underestimated). </a:t>
            </a:r>
            <a:r>
              <a:rPr lang="en-US" sz="800" baseline="30000" dirty="0"/>
              <a:t>2</a:t>
            </a:r>
            <a:r>
              <a:rPr lang="en-US" sz="800" dirty="0"/>
              <a:t>SCAP/SREBP/NPC1 orthologues and proteins with less than nine identifiable transmembrane domains were excluded.			</a:t>
            </a:r>
          </a:p>
        </p:txBody>
      </p:sp>
      <p:pic>
        <p:nvPicPr>
          <p:cNvPr id="12" name="Picture 11" descr="A picture containing diagram&#10;&#10;Description automatically generated">
            <a:extLst>
              <a:ext uri="{FF2B5EF4-FFF2-40B4-BE49-F238E27FC236}">
                <a16:creationId xmlns:a16="http://schemas.microsoft.com/office/drawing/2014/main" id="{E9DED8B2-3EBA-7D4D-A5D7-D8D182CC3D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34" t="21559" r="25290" b="20235"/>
          <a:stretch/>
        </p:blipFill>
        <p:spPr>
          <a:xfrm>
            <a:off x="2334634" y="3012864"/>
            <a:ext cx="4513471" cy="2029966"/>
          </a:xfrm>
          <a:prstGeom prst="rect">
            <a:avLst/>
          </a:prstGeom>
        </p:spPr>
      </p:pic>
      <p:pic>
        <p:nvPicPr>
          <p:cNvPr id="4" name="Picture 3" descr="A picture containing diagram&#10;&#10;Description automatically generated">
            <a:extLst>
              <a:ext uri="{FF2B5EF4-FFF2-40B4-BE49-F238E27FC236}">
                <a16:creationId xmlns:a16="http://schemas.microsoft.com/office/drawing/2014/main" id="{1E6EF829-EB13-1045-8956-4ED0741C34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24981" r="23704" b="20267"/>
          <a:stretch/>
        </p:blipFill>
        <p:spPr>
          <a:xfrm>
            <a:off x="0" y="3565221"/>
            <a:ext cx="2628698" cy="925253"/>
          </a:xfrm>
          <a:prstGeom prst="rect">
            <a:avLst/>
          </a:prstGeom>
        </p:spPr>
      </p:pic>
      <p:pic>
        <p:nvPicPr>
          <p:cNvPr id="11" name="Picture 10" descr="A picture containing diagram&#10;&#10;Description automatically generated">
            <a:extLst>
              <a:ext uri="{FF2B5EF4-FFF2-40B4-BE49-F238E27FC236}">
                <a16:creationId xmlns:a16="http://schemas.microsoft.com/office/drawing/2014/main" id="{DC88B31F-7B02-1D4A-811D-BFCB2A10126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83" t="21888" r="23871" b="21887"/>
          <a:stretch/>
        </p:blipFill>
        <p:spPr>
          <a:xfrm>
            <a:off x="218350" y="43264"/>
            <a:ext cx="6421300" cy="291561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4346DB8-6C0C-FC40-B9C4-92AC21E576CA}"/>
              </a:ext>
            </a:extLst>
          </p:cNvPr>
          <p:cNvSpPr txBox="1"/>
          <p:nvPr/>
        </p:nvSpPr>
        <p:spPr>
          <a:xfrm>
            <a:off x="47177" y="2918636"/>
            <a:ext cx="175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89F6902-EF9F-9B4F-99B8-F297AC9C8AAB}"/>
              </a:ext>
            </a:extLst>
          </p:cNvPr>
          <p:cNvSpPr txBox="1"/>
          <p:nvPr/>
        </p:nvSpPr>
        <p:spPr>
          <a:xfrm>
            <a:off x="2465589" y="2918636"/>
            <a:ext cx="175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2EF113-E416-5C4A-A9DA-43D93928909C}"/>
              </a:ext>
            </a:extLst>
          </p:cNvPr>
          <p:cNvSpPr txBox="1"/>
          <p:nvPr/>
        </p:nvSpPr>
        <p:spPr>
          <a:xfrm>
            <a:off x="47177" y="-10483"/>
            <a:ext cx="175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9B40A0-4AF8-7440-845C-144B6992EB62}"/>
              </a:ext>
            </a:extLst>
          </p:cNvPr>
          <p:cNvSpPr txBox="1"/>
          <p:nvPr/>
        </p:nvSpPr>
        <p:spPr>
          <a:xfrm>
            <a:off x="47177" y="4895000"/>
            <a:ext cx="175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1E7D66DF-8C33-6A48-8E59-683F23EC62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6479899"/>
              </p:ext>
            </p:extLst>
          </p:nvPr>
        </p:nvGraphicFramePr>
        <p:xfrm>
          <a:off x="1688236" y="5052119"/>
          <a:ext cx="3206515" cy="2689392"/>
        </p:xfrm>
        <a:graphic>
          <a:graphicData uri="http://schemas.openxmlformats.org/drawingml/2006/table">
            <a:tbl>
              <a:tblPr/>
              <a:tblGrid>
                <a:gridCol w="439738">
                  <a:extLst>
                    <a:ext uri="{9D8B030D-6E8A-4147-A177-3AD203B41FA5}">
                      <a16:colId xmlns:a16="http://schemas.microsoft.com/office/drawing/2014/main" val="4082495613"/>
                    </a:ext>
                  </a:extLst>
                </a:gridCol>
                <a:gridCol w="1472547">
                  <a:extLst>
                    <a:ext uri="{9D8B030D-6E8A-4147-A177-3AD203B41FA5}">
                      <a16:colId xmlns:a16="http://schemas.microsoft.com/office/drawing/2014/main" val="1385234876"/>
                    </a:ext>
                  </a:extLst>
                </a:gridCol>
                <a:gridCol w="647115">
                  <a:extLst>
                    <a:ext uri="{9D8B030D-6E8A-4147-A177-3AD203B41FA5}">
                      <a16:colId xmlns:a16="http://schemas.microsoft.com/office/drawing/2014/main" val="1746962125"/>
                    </a:ext>
                  </a:extLst>
                </a:gridCol>
                <a:gridCol w="647115">
                  <a:extLst>
                    <a:ext uri="{9D8B030D-6E8A-4147-A177-3AD203B41FA5}">
                      <a16:colId xmlns:a16="http://schemas.microsoft.com/office/drawing/2014/main" val="984670650"/>
                    </a:ext>
                  </a:extLst>
                </a:gridCol>
              </a:tblGrid>
              <a:tr h="563412">
                <a:tc>
                  <a:txBody>
                    <a:bodyPr/>
                    <a:lstStyle/>
                    <a:p>
                      <a:pPr algn="ctr" fontAlgn="ctr"/>
                      <a:endParaRPr lang="en-D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matode specie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ands (WRT, HOG, QUA, GRD &amp; GRL)</a:t>
                      </a:r>
                      <a:r>
                        <a:rPr lang="en-GB" sz="8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eptors (PTC, PTR, PTD)</a:t>
                      </a:r>
                      <a:r>
                        <a:rPr lang="en-GB" sz="8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4112173"/>
                  </a:ext>
                </a:extLst>
              </a:tr>
              <a:tr h="13381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 I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chinella spirali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7142337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chinella pseudospirali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940410"/>
                  </a:ext>
                </a:extLst>
              </a:tr>
              <a:tr h="13381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 III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xocara cani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428193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caris suum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6672834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chocerca</a:t>
                      </a:r>
                      <a:r>
                        <a:rPr lang="en-GB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olvulu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2152612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ugia malayi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1758967"/>
                  </a:ext>
                </a:extLst>
              </a:tr>
              <a:tr h="13381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 V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enorhabditis elegan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763762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stionchus pacificu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4542985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ligmosomoides polygyru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031106"/>
                  </a:ext>
                </a:extLst>
              </a:tr>
              <a:tr h="13381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ppostrongylus brasiliensis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297291"/>
                  </a:ext>
                </a:extLst>
              </a:tr>
              <a:tr h="1338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 IVa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ongyloides ratti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2282300"/>
                  </a:ext>
                </a:extLst>
              </a:tr>
              <a:tr h="1338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 IVb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odera pallida</a:t>
                      </a:r>
                    </a:p>
                  </a:txBody>
                  <a:tcPr marL="9525" marR="95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85725" marT="9525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70435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880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3811305467C74494CB40DB3D5262DA" ma:contentTypeVersion="8" ma:contentTypeDescription="Create a new document." ma:contentTypeScope="" ma:versionID="8fc5784638860716a3723dffd2d08673">
  <xsd:schema xmlns:xsd="http://www.w3.org/2001/XMLSchema" xmlns:xs="http://www.w3.org/2001/XMLSchema" xmlns:p="http://schemas.microsoft.com/office/2006/metadata/properties" xmlns:ns2="c0db18e3-4c06-4c9d-ab15-91da0ad61027" targetNamespace="http://schemas.microsoft.com/office/2006/metadata/properties" ma:root="true" ma:fieldsID="e03991102f04ff9dcf3a5d4219758345" ns2:_="">
    <xsd:import namespace="c0db18e3-4c06-4c9d-ab15-91da0ad61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db18e3-4c06-4c9d-ab15-91da0ad610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DEB5FA8-875A-44EF-80EB-E054E5A9FB1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1C21D91-086B-4E2D-9870-AC72BE2FB81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0db18e3-4c06-4c9d-ab15-91da0ad610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9F95E38-C7F3-4B8E-89DE-4DC81991A563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2</TotalTime>
  <Words>314</Words>
  <Application>Microsoft Macintosh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e Benedetto</dc:creator>
  <cp:lastModifiedBy>Alejandra Zarate</cp:lastModifiedBy>
  <cp:revision>21</cp:revision>
  <dcterms:created xsi:type="dcterms:W3CDTF">2022-01-08T13:37:34Z</dcterms:created>
  <dcterms:modified xsi:type="dcterms:W3CDTF">2022-03-03T18:35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3811305467C74494CB40DB3D5262DA</vt:lpwstr>
  </property>
</Properties>
</file>